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091FF4-E088-4659-A320-37DA5505EA26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01089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직사각형 207"/>
          <p:cNvSpPr/>
          <p:nvPr/>
        </p:nvSpPr>
        <p:spPr>
          <a:xfrm>
            <a:off x="165100" y="7989733"/>
            <a:ext cx="11696700" cy="1128496"/>
          </a:xfrm>
          <a:prstGeom prst="rect">
            <a:avLst/>
          </a:prstGeom>
        </p:spPr>
        <p:txBody>
          <a:bodyPr wrap="square" lIns="142224" tIns="71111" rIns="142224" bIns="71111">
            <a:spAutoFit/>
          </a:bodyPr>
          <a:lstStyle/>
          <a:p>
            <a:pPr marL="648000" indent="-720000" algn="just"/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Fusion transcripts in validation sets. (A) Gene fusion between </a:t>
            </a:r>
            <a:r>
              <a:rPr lang="en-US" altLang="ko-KR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MYND8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PT9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by </a:t>
            </a:r>
            <a:r>
              <a:rPr lang="en-US" altLang="ko-K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chromosomal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mplex. (B) Gene fusion between </a:t>
            </a:r>
            <a:r>
              <a:rPr lang="en-US" altLang="ko-KR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2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R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by </a:t>
            </a:r>
            <a:r>
              <a:rPr lang="en-US" altLang="ko-K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rachromosomal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mplex. Fusion junction was red arrow, and validation of fusion transcript by RT-PCR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anger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 in patient #3. Prediction of fusion protein was analyzed by conserved domain database. </a:t>
            </a:r>
            <a:endParaRPr lang="ko-KR" altLang="en-US" sz="1600" dirty="0"/>
          </a:p>
        </p:txBody>
      </p:sp>
      <p:grpSp>
        <p:nvGrpSpPr>
          <p:cNvPr id="22" name="그룹 21"/>
          <p:cNvGrpSpPr/>
          <p:nvPr/>
        </p:nvGrpSpPr>
        <p:grpSpPr>
          <a:xfrm>
            <a:off x="1173480" y="63500"/>
            <a:ext cx="9850120" cy="7883590"/>
            <a:chOff x="1173480" y="63500"/>
            <a:chExt cx="9850120" cy="7883590"/>
          </a:xfrm>
        </p:grpSpPr>
        <p:pic>
          <p:nvPicPr>
            <p:cNvPr id="621" name="그림 62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04901" y="258321"/>
              <a:ext cx="9418699" cy="7688769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8263325" y="1868699"/>
              <a:ext cx="546450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M</a:t>
              </a:r>
              <a:endParaRPr lang="ko-KR" altLang="en-US" b="1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8921868" y="1868699"/>
              <a:ext cx="546450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NC</a:t>
              </a:r>
              <a:endParaRPr lang="ko-KR" altLang="en-US" b="1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9580410" y="1868699"/>
              <a:ext cx="546450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PC</a:t>
              </a:r>
              <a:endParaRPr lang="ko-KR" altLang="en-US" b="1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238953" y="1868699"/>
              <a:ext cx="546450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LM</a:t>
              </a:r>
              <a:endParaRPr lang="ko-KR" altLang="en-US" b="1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151232" y="6061876"/>
              <a:ext cx="546450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M</a:t>
              </a:r>
              <a:endParaRPr lang="ko-KR" altLang="en-US" b="1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856480" y="6061876"/>
              <a:ext cx="546450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NC</a:t>
              </a:r>
              <a:endParaRPr lang="ko-KR" altLang="en-US" b="1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561728" y="6061876"/>
              <a:ext cx="546450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PC</a:t>
              </a:r>
              <a:endParaRPr lang="ko-KR" altLang="en-US" b="1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266976" y="6061876"/>
              <a:ext cx="546450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LM</a:t>
              </a:r>
              <a:endParaRPr lang="ko-KR" altLang="en-US" b="1"/>
            </a:p>
          </p:txBody>
        </p:sp>
        <p:cxnSp>
          <p:nvCxnSpPr>
            <p:cNvPr id="12" name="직선 연결선 11"/>
            <p:cNvCxnSpPr/>
            <p:nvPr/>
          </p:nvCxnSpPr>
          <p:spPr>
            <a:xfrm>
              <a:off x="8809775" y="1925555"/>
              <a:ext cx="189155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8823787" y="1630611"/>
              <a:ext cx="18635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Patient #3</a:t>
              </a:r>
              <a:endParaRPr lang="ko-KR" altLang="en-US" b="1"/>
            </a:p>
          </p:txBody>
        </p:sp>
        <p:cxnSp>
          <p:nvCxnSpPr>
            <p:cNvPr id="16" name="직선 연결선 15"/>
            <p:cNvCxnSpPr/>
            <p:nvPr/>
          </p:nvCxnSpPr>
          <p:spPr>
            <a:xfrm>
              <a:off x="8809775" y="6104519"/>
              <a:ext cx="189155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8823787" y="5809575"/>
              <a:ext cx="18635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/>
                <a:t>Patient #3</a:t>
              </a:r>
              <a:endParaRPr lang="ko-KR" altLang="en-US" b="1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73480" y="63500"/>
              <a:ext cx="64453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ko-KR" altLang="en-US" sz="2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173480" y="4142964"/>
              <a:ext cx="64453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ko-KR" altLang="en-US" sz="2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4" name="직선 화살표 연결선 23"/>
          <p:cNvCxnSpPr/>
          <p:nvPr/>
        </p:nvCxnSpPr>
        <p:spPr>
          <a:xfrm>
            <a:off x="4165600" y="2590800"/>
            <a:ext cx="0" cy="720000"/>
          </a:xfrm>
          <a:prstGeom prst="straightConnector1">
            <a:avLst/>
          </a:prstGeom>
          <a:ln w="19050">
            <a:solidFill>
              <a:srgbClr val="FF0000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화살표 연결선 26"/>
          <p:cNvCxnSpPr/>
          <p:nvPr/>
        </p:nvCxnSpPr>
        <p:spPr>
          <a:xfrm>
            <a:off x="4330700" y="6654800"/>
            <a:ext cx="0" cy="720000"/>
          </a:xfrm>
          <a:prstGeom prst="straightConnector1">
            <a:avLst/>
          </a:prstGeom>
          <a:ln w="19050">
            <a:solidFill>
              <a:srgbClr val="FF0000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14819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91</Words>
  <Application>Microsoft Office PowerPoint</Application>
  <PresentationFormat>Custom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45:46Z</dcterms:modified>
</cp:coreProperties>
</file>